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6" r:id="rId4"/>
    <p:sldId id="262" r:id="rId5"/>
    <p:sldId id="257" r:id="rId6"/>
    <p:sldId id="261" r:id="rId7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2B634C-E454-4DAF-BEB6-DB1A6AE173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205699-DF3B-4705-B534-549F47F0CE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07090B-1CAF-46D3-A548-940E5809B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EF4F6-781E-400B-915F-05BE0170D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3FE1EA-8A8E-4AFC-BF55-CEEF7626E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413167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4873A-95B1-47C7-98BD-FF3D65055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141468-8659-44FD-97D3-E714D6FD59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A294E8-3B67-486C-BE54-A62CA5DAB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A67DC1-F62B-4485-A059-D2B19AABF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AC6B07-7A8B-4728-8974-0B10D3B63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35534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8EBCBE-EAE1-4BD4-A193-035F617ABD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9DDE48-5DCA-4919-BA48-39746D3D42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5D798-7DAC-483B-937E-C4E799DD5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D389C9-21A4-4E1C-A99E-BD1CE8B61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DE0658-D6D1-4DAE-965E-C89662140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687223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D6C100-090E-40FC-8406-AA03BC50F6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FFF1D0-6E8B-4CEC-914D-9BD9CB9ED8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66455-22F5-48CD-9F0A-04BD9651E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731E0-9A5F-4D11-AE42-D54725672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800D64-9C0B-40E3-9DAC-42312B016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692096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6D276-7801-45F7-A27D-CC715C6F5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18055C-A99E-40BD-B86D-7590C9E6A5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BBD15D-3FA3-4C5F-B7E8-FFCFDF8B1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5C3372-082E-47F7-A0CC-D66FBB13C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5A1EB6-FB4A-431D-93C5-AED77CF51F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81777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17D7E-6A95-49AB-ACF3-0D2B5A3F3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975887-3C34-4F2A-8F63-90F9475E4C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B37214-6A24-4DD2-A2BA-E5D73C5DCF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A36E09-BCC3-4CB3-88D8-7B093D722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BEA1F1-2B65-492B-8975-6D639C1FF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A1612E-1B12-42D4-A33B-0E6380B67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39786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C05C3-EC78-4FDB-ADBE-59EE26C70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8F6C4C-AF48-40AC-B35C-48162E6B2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2305CA-3210-4761-8B92-F6689C0F18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EA9D11-F8C4-4BEC-BBA8-7F3AEF5D9F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70FD9A-AA94-4A5A-8965-C9626DC68C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A7AC68-1891-4CAE-B88C-F9C16A6CF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7BC358-286B-47FF-9529-E4373897F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A19529-721C-4952-9468-EF3CE90A2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901718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C7A7A-B89D-49CE-9E5F-4C6AFEA23F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C56B82-0B25-4C7D-85D5-8E8B59165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28119-3B4F-4F52-A40E-A381E24A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559A43-DEE1-4094-B5D4-F9D95538F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249118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A95531-71F5-40F6-81AE-741626DF3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0AE86B-08F1-45CB-A724-22F42F349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C3286B-AEFB-4E5F-B3FF-DAA49ABC6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746666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1A5F2A-E081-4BB3-B327-28F581344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EC45DA-869B-44A4-903E-FB5410F723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BA0466-8485-43B7-BD44-91CC3B8D3E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C70A9C-0548-4EFD-9227-495C60859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87905B-96F2-4A72-96FA-5E60D2BD5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19ED36-C0FC-47DD-9B83-34B7EE6DE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175985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6A30F-4B09-421A-A96D-0DBEB7028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6834EC-155C-4AB1-8ABC-BBEA8C698B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EB0965-D16D-4C3F-9251-BCC5E18DAE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1C9AFD-467A-42EB-8412-678E622E3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55EEBC-F28D-4B52-85CB-3BF75B84F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6DA710-45AC-45F8-AA2F-451F791A6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462288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262D72-EDC2-4101-9D7F-19340D850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A9954C-B5B0-4A66-97D8-66C21E6AA8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730643-BA80-43AF-BEB0-58889289E6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97BED-E9C3-4E64-991C-AD598519CEC1}" type="datetimeFigureOut">
              <a:rPr lang="en-BE" smtClean="0"/>
              <a:t>18/07/2023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1E001-11C6-4DBF-B893-A559DF35FE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A519F-8F5A-49E4-B046-7A11FED3D6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B823F-B844-4EFF-AB57-AE027DB4E1A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504245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7.jpeg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10" Type="http://schemas.openxmlformats.org/officeDocument/2006/relationships/image" Target="../media/image6.emf"/><Relationship Id="rId4" Type="http://schemas.openxmlformats.org/officeDocument/2006/relationships/image" Target="../media/image8.jpeg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13" Type="http://schemas.openxmlformats.org/officeDocument/2006/relationships/image" Target="../media/image22.jpg"/><Relationship Id="rId3" Type="http://schemas.openxmlformats.org/officeDocument/2006/relationships/image" Target="../media/image12.jpg"/><Relationship Id="rId7" Type="http://schemas.openxmlformats.org/officeDocument/2006/relationships/image" Target="../media/image16.jpg"/><Relationship Id="rId12" Type="http://schemas.openxmlformats.org/officeDocument/2006/relationships/image" Target="../media/image21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jpg"/><Relationship Id="rId11" Type="http://schemas.openxmlformats.org/officeDocument/2006/relationships/image" Target="../media/image20.jpg"/><Relationship Id="rId5" Type="http://schemas.openxmlformats.org/officeDocument/2006/relationships/image" Target="../media/image14.jpg"/><Relationship Id="rId15" Type="http://schemas.openxmlformats.org/officeDocument/2006/relationships/image" Target="../media/image24.jpg"/><Relationship Id="rId10" Type="http://schemas.openxmlformats.org/officeDocument/2006/relationships/image" Target="../media/image19.jpg"/><Relationship Id="rId4" Type="http://schemas.openxmlformats.org/officeDocument/2006/relationships/image" Target="../media/image13.jpg"/><Relationship Id="rId9" Type="http://schemas.openxmlformats.org/officeDocument/2006/relationships/image" Target="../media/image18.jpg"/><Relationship Id="rId14" Type="http://schemas.openxmlformats.org/officeDocument/2006/relationships/image" Target="../media/image23.jp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7E34B6A-97E0-4E11-A1E6-676035F93EA0}"/>
              </a:ext>
            </a:extLst>
          </p:cNvPr>
          <p:cNvSpPr txBox="1"/>
          <p:nvPr/>
        </p:nvSpPr>
        <p:spPr>
          <a:xfrm>
            <a:off x="2238427" y="2747238"/>
            <a:ext cx="31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B</a:t>
            </a:r>
            <a:endParaRPr lang="en-BE" sz="1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2D8B52-F529-46C2-81A7-C031B1F4A1EA}"/>
              </a:ext>
            </a:extLst>
          </p:cNvPr>
          <p:cNvSpPr txBox="1"/>
          <p:nvPr/>
        </p:nvSpPr>
        <p:spPr>
          <a:xfrm>
            <a:off x="4707068" y="2747238"/>
            <a:ext cx="31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C</a:t>
            </a:r>
            <a:endParaRPr lang="en-BE" sz="1600" b="1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FA5903C-2958-4F45-A58B-C1409809BC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5528800"/>
              </p:ext>
            </p:extLst>
          </p:nvPr>
        </p:nvGraphicFramePr>
        <p:xfrm>
          <a:off x="2284339" y="2916515"/>
          <a:ext cx="2724150" cy="2449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8" name="Prism 9" r:id="rId3" imgW="2724494" imgH="2448819" progId="Prism9.Document">
                  <p:embed/>
                </p:oleObj>
              </mc:Choice>
              <mc:Fallback>
                <p:oleObj name="Prism 9" r:id="rId3" imgW="2724494" imgH="24488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84339" y="2916515"/>
                        <a:ext cx="2724150" cy="2449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2AC018F-798F-44B2-AD44-C34F922928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2376504"/>
              </p:ext>
            </p:extLst>
          </p:nvPr>
        </p:nvGraphicFramePr>
        <p:xfrm>
          <a:off x="4666816" y="2916515"/>
          <a:ext cx="2724150" cy="2449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9" name="Prism 9" r:id="rId5" imgW="2724494" imgH="2448819" progId="Prism9.Document">
                  <p:embed/>
                </p:oleObj>
              </mc:Choice>
              <mc:Fallback>
                <p:oleObj name="Prism 9" r:id="rId5" imgW="2724494" imgH="24488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66816" y="2916515"/>
                        <a:ext cx="2724150" cy="2449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B275ECE-4F8F-4D74-B417-F043DA4F5E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5858251"/>
              </p:ext>
            </p:extLst>
          </p:nvPr>
        </p:nvGraphicFramePr>
        <p:xfrm>
          <a:off x="2447270" y="900101"/>
          <a:ext cx="4221978" cy="1356536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388106">
                  <a:extLst>
                    <a:ext uri="{9D8B030D-6E8A-4147-A177-3AD203B41FA5}">
                      <a16:colId xmlns:a16="http://schemas.microsoft.com/office/drawing/2014/main" val="683427487"/>
                    </a:ext>
                  </a:extLst>
                </a:gridCol>
                <a:gridCol w="1022178">
                  <a:extLst>
                    <a:ext uri="{9D8B030D-6E8A-4147-A177-3AD203B41FA5}">
                      <a16:colId xmlns:a16="http://schemas.microsoft.com/office/drawing/2014/main" val="2223075058"/>
                    </a:ext>
                  </a:extLst>
                </a:gridCol>
                <a:gridCol w="1811694">
                  <a:extLst>
                    <a:ext uri="{9D8B030D-6E8A-4147-A177-3AD203B41FA5}">
                      <a16:colId xmlns:a16="http://schemas.microsoft.com/office/drawing/2014/main" val="1011340405"/>
                    </a:ext>
                  </a:extLst>
                </a:gridCol>
              </a:tblGrid>
              <a:tr h="33913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Expecte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Observed (at weaning age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65197800"/>
                  </a:ext>
                </a:extLst>
              </a:tr>
              <a:tr h="33913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0% (14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2% (152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9835903"/>
                  </a:ext>
                </a:extLst>
              </a:tr>
              <a:tr h="33913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OTULIN</a:t>
                      </a:r>
                      <a:r>
                        <a:rPr lang="en-US" sz="1100" baseline="30000">
                          <a:effectLst/>
                        </a:rPr>
                        <a:t>IEC-K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0% (14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48% (140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33584466"/>
                  </a:ext>
                </a:extLst>
              </a:tr>
              <a:tr h="33913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otal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% (292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% (292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20659639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894A46A-3703-4D24-B73C-DE0214BDAB1B}"/>
              </a:ext>
            </a:extLst>
          </p:cNvPr>
          <p:cNvSpPr txBox="1"/>
          <p:nvPr/>
        </p:nvSpPr>
        <p:spPr>
          <a:xfrm>
            <a:off x="2238427" y="561548"/>
            <a:ext cx="31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A</a:t>
            </a:r>
            <a:endParaRPr lang="en-BE" sz="16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F01FEA-DBD7-4EBB-AF39-90A74F913C7A}"/>
              </a:ext>
            </a:extLst>
          </p:cNvPr>
          <p:cNvSpPr txBox="1"/>
          <p:nvPr/>
        </p:nvSpPr>
        <p:spPr>
          <a:xfrm>
            <a:off x="906011" y="5788404"/>
            <a:ext cx="104610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1. OTULIN</a:t>
            </a:r>
            <a:r>
              <a:rPr lang="en-US" sz="1200" b="1" baseline="30000" dirty="0"/>
              <a:t>IEC-KO</a:t>
            </a:r>
            <a:r>
              <a:rPr lang="en-US" sz="1200" b="1" dirty="0"/>
              <a:t> mice have normal body weight.</a:t>
            </a:r>
            <a:r>
              <a:rPr lang="en-US" sz="1200" dirty="0"/>
              <a:t> (A) Analysis of the expected and observed offspring of mice at weaning age from the intercrosses of </a:t>
            </a:r>
            <a:r>
              <a:rPr lang="en-US" sz="1200" i="1" dirty="0" err="1"/>
              <a:t>Otulin</a:t>
            </a:r>
            <a:r>
              <a:rPr lang="en-US" sz="1200" i="1" baseline="30000" dirty="0" err="1"/>
              <a:t>FL</a:t>
            </a:r>
            <a:r>
              <a:rPr lang="en-US" sz="1200" i="1" baseline="30000" dirty="0"/>
              <a:t>/</a:t>
            </a:r>
            <a:r>
              <a:rPr lang="en-US" sz="1200" i="1" baseline="30000" dirty="0" err="1"/>
              <a:t>FL</a:t>
            </a:r>
            <a:r>
              <a:rPr lang="en-US" sz="1200" i="1" dirty="0" err="1"/>
              <a:t>Villin-Cre</a:t>
            </a:r>
            <a:r>
              <a:rPr lang="en-US" sz="1200" i="1" baseline="30000" dirty="0"/>
              <a:t>+/+</a:t>
            </a:r>
            <a:r>
              <a:rPr lang="en-US" sz="1200" dirty="0"/>
              <a:t> with </a:t>
            </a:r>
            <a:r>
              <a:rPr lang="en-US" sz="1200" i="1" dirty="0" err="1"/>
              <a:t>Otulin</a:t>
            </a:r>
            <a:r>
              <a:rPr lang="en-US" sz="1200" i="1" baseline="30000" dirty="0" err="1"/>
              <a:t>FL</a:t>
            </a:r>
            <a:r>
              <a:rPr lang="en-US" sz="1200" i="1" baseline="30000" dirty="0"/>
              <a:t>/</a:t>
            </a:r>
            <a:r>
              <a:rPr lang="en-US" sz="1200" i="1" baseline="30000" dirty="0" err="1"/>
              <a:t>FL</a:t>
            </a:r>
            <a:r>
              <a:rPr lang="en-US" sz="1200" i="1" dirty="0" err="1"/>
              <a:t>Villin-Cre</a:t>
            </a:r>
            <a:r>
              <a:rPr lang="en-US" sz="1200" i="1" baseline="30000" dirty="0" err="1"/>
              <a:t>Tg</a:t>
            </a:r>
            <a:r>
              <a:rPr lang="en-US" sz="1200" i="1" baseline="30000" dirty="0"/>
              <a:t>/+</a:t>
            </a:r>
            <a:r>
              <a:rPr lang="en-US" sz="1200" baseline="-25000" dirty="0"/>
              <a:t>.</a:t>
            </a:r>
            <a:r>
              <a:rPr lang="en-US" sz="1200" dirty="0"/>
              <a:t> (B-C)</a:t>
            </a:r>
            <a:r>
              <a:rPr lang="en-US" sz="1200" b="1" dirty="0"/>
              <a:t> </a:t>
            </a:r>
            <a:r>
              <a:rPr lang="en-US" sz="1200" dirty="0"/>
              <a:t>Body weight of</a:t>
            </a:r>
            <a:r>
              <a:rPr lang="en-US" sz="1200" b="1" dirty="0"/>
              <a:t> </a:t>
            </a:r>
            <a:r>
              <a:rPr lang="en-US" sz="1200" dirty="0"/>
              <a:t>10-week old (n = 15 for each group) (B) and 30-week old (C) WT (n = 6) 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n = 8) mice. </a:t>
            </a:r>
            <a:endParaRPr lang="en-BE" sz="1200" dirty="0"/>
          </a:p>
          <a:p>
            <a:endParaRPr lang="en-BE" sz="1200" dirty="0"/>
          </a:p>
        </p:txBody>
      </p:sp>
    </p:spTree>
    <p:extLst>
      <p:ext uri="{BB962C8B-B14F-4D97-AF65-F5344CB8AC3E}">
        <p14:creationId xmlns:p14="http://schemas.microsoft.com/office/powerpoint/2010/main" val="487024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6934689-3C07-4300-BD2C-BDF4042ED9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594" y="87552"/>
            <a:ext cx="10068424" cy="587551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054AB4D-67FD-40FF-90B0-B7C70D76AA76}"/>
              </a:ext>
            </a:extLst>
          </p:cNvPr>
          <p:cNvSpPr txBox="1"/>
          <p:nvPr/>
        </p:nvSpPr>
        <p:spPr>
          <a:xfrm>
            <a:off x="553673" y="6140741"/>
            <a:ext cx="11190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2. Epithelial gene expression in OTULIN</a:t>
            </a:r>
            <a:r>
              <a:rPr lang="en-US" sz="1200" b="1" baseline="30000" dirty="0"/>
              <a:t>IEC-KO</a:t>
            </a:r>
            <a:r>
              <a:rPr lang="en-US" sz="1200" i="1" dirty="0"/>
              <a:t> </a:t>
            </a:r>
            <a:r>
              <a:rPr lang="en-US" sz="1200" b="1" dirty="0"/>
              <a:t>mice</a:t>
            </a:r>
            <a:r>
              <a:rPr lang="en-US" sz="1200" dirty="0"/>
              <a:t>. Quantitative PCR analysis on IEC lysates from the small intestine (SI) and colon (COL) from 10- to 15-week-old WT (SI, n = 3; COL, n = 7) 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SI, n = 4; COL, n = 6) mice. </a:t>
            </a:r>
            <a:endParaRPr lang="en-BE" sz="1200" dirty="0"/>
          </a:p>
        </p:txBody>
      </p:sp>
    </p:spTree>
    <p:extLst>
      <p:ext uri="{BB962C8B-B14F-4D97-AF65-F5344CB8AC3E}">
        <p14:creationId xmlns:p14="http://schemas.microsoft.com/office/powerpoint/2010/main" val="1388041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3C2FAC2-A7BD-4AC5-B699-58EEF2AABB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9015" y="181092"/>
            <a:ext cx="8970271" cy="54479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6DB75C0-2F86-4BD5-B911-6BEA85678A21}"/>
              </a:ext>
            </a:extLst>
          </p:cNvPr>
          <p:cNvSpPr txBox="1"/>
          <p:nvPr/>
        </p:nvSpPr>
        <p:spPr>
          <a:xfrm>
            <a:off x="324374" y="5548234"/>
            <a:ext cx="1154325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3. TNF induces IEC apoptosis and lethality in OTULIN</a:t>
            </a:r>
            <a:r>
              <a:rPr lang="en-US" sz="1200" b="1" baseline="30000" dirty="0"/>
              <a:t>IEC-KO</a:t>
            </a:r>
            <a:r>
              <a:rPr lang="en-US" sz="1200" i="1" dirty="0"/>
              <a:t> </a:t>
            </a:r>
            <a:r>
              <a:rPr lang="en-US" sz="1200" b="1" dirty="0"/>
              <a:t>mice</a:t>
            </a:r>
            <a:r>
              <a:rPr lang="en-US" sz="1200" dirty="0"/>
              <a:t>.</a:t>
            </a:r>
            <a:r>
              <a:rPr lang="en-US" sz="1200" i="1" dirty="0"/>
              <a:t> </a:t>
            </a:r>
            <a:r>
              <a:rPr lang="en-US" sz="1200" dirty="0"/>
              <a:t>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and control littermate mice were injected intraperitoneally with 5 µg of recombinant mouse TNF per 20 g body weight. (A) Quantitative PCR analysis of inflammatory cytokines </a:t>
            </a:r>
            <a:r>
              <a:rPr lang="en-US" sz="1200" i="1" dirty="0"/>
              <a:t>Il6, Ccl2, Ccl5, </a:t>
            </a:r>
            <a:r>
              <a:rPr lang="en-US" sz="1200" i="1" dirty="0" err="1"/>
              <a:t>Tnf</a:t>
            </a:r>
            <a:r>
              <a:rPr lang="en-US" sz="1200" i="1" dirty="0"/>
              <a:t> </a:t>
            </a:r>
            <a:r>
              <a:rPr lang="en-US" sz="1200" dirty="0"/>
              <a:t>and</a:t>
            </a:r>
            <a:r>
              <a:rPr lang="en-US" sz="1200" i="1" dirty="0"/>
              <a:t> Il1b, </a:t>
            </a:r>
            <a:r>
              <a:rPr lang="en-US" sz="1200" dirty="0"/>
              <a:t>in IEC lysates of WT</a:t>
            </a:r>
            <a:r>
              <a:rPr lang="en-US" sz="1200" i="1" dirty="0"/>
              <a:t> </a:t>
            </a:r>
            <a:r>
              <a:rPr lang="en-US" sz="1200" dirty="0"/>
              <a:t>(t0, n = 7; t2, n = 7; t3, n = 8)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t0, n = 10; t2, n = 7; t3, n = 8) mice. Data are represented as mean ± SEM. * p&lt; 0,05; ** p&lt; 0,01; **** p&lt; 0,0001 (B) Quantifications of lamina propria myeloid cell subsets in small intestine of WT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mice (n = 4), by flow cytometry analysis, 3 hours after TNF injection. Data are represented as mean ± SEM. * p&lt; 0,05; ** p&lt; 0,01. (C) Representative images of F4/80 stained sections of the small intestine of 27-30-week old OTULIN</a:t>
            </a:r>
            <a:r>
              <a:rPr lang="en-US" sz="1200" baseline="30000" dirty="0"/>
              <a:t>IEC-KO </a:t>
            </a:r>
            <a:r>
              <a:rPr lang="en-US" sz="1200" dirty="0"/>
              <a:t>and control (WT) littermate mice 3 hours after TNF injection. Scale bar overview, 100 </a:t>
            </a:r>
            <a:r>
              <a:rPr lang="en-US" sz="1200" dirty="0" err="1"/>
              <a:t>μm</a:t>
            </a:r>
            <a:r>
              <a:rPr lang="en-US" sz="1200" dirty="0"/>
              <a:t>; zoom, 50 </a:t>
            </a:r>
            <a:r>
              <a:rPr lang="en-US" sz="1200" dirty="0" err="1"/>
              <a:t>μm</a:t>
            </a:r>
            <a:r>
              <a:rPr lang="en-US" sz="1200" dirty="0"/>
              <a:t>. (D) Quantification of the number of F4/80-positive cells in the small intestine of WT and OTULIN</a:t>
            </a:r>
            <a:r>
              <a:rPr lang="en-US" sz="1200" baseline="30000" dirty="0"/>
              <a:t>IEC-KO </a:t>
            </a:r>
            <a:r>
              <a:rPr lang="en-US" sz="1200" dirty="0"/>
              <a:t>mice (n = 4). Data are represented as mean ± SEM, * p&lt; 0,05; ** p&lt; 0,01.</a:t>
            </a:r>
            <a:endParaRPr lang="en-BE" sz="1200" dirty="0"/>
          </a:p>
          <a:p>
            <a:endParaRPr lang="en-BE" sz="1200" dirty="0"/>
          </a:p>
        </p:txBody>
      </p:sp>
    </p:spTree>
    <p:extLst>
      <p:ext uri="{BB962C8B-B14F-4D97-AF65-F5344CB8AC3E}">
        <p14:creationId xmlns:p14="http://schemas.microsoft.com/office/powerpoint/2010/main" val="23419303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7E34B6A-97E0-4E11-A1E6-676035F93EA0}"/>
              </a:ext>
            </a:extLst>
          </p:cNvPr>
          <p:cNvSpPr txBox="1"/>
          <p:nvPr/>
        </p:nvSpPr>
        <p:spPr>
          <a:xfrm>
            <a:off x="1377752" y="1022163"/>
            <a:ext cx="283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A</a:t>
            </a:r>
            <a:endParaRPr lang="en-BE" sz="1600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DA900E7-3DAB-4E3E-8B39-38208627A5C2}"/>
              </a:ext>
            </a:extLst>
          </p:cNvPr>
          <p:cNvGrpSpPr/>
          <p:nvPr/>
        </p:nvGrpSpPr>
        <p:grpSpPr>
          <a:xfrm>
            <a:off x="1448136" y="1048625"/>
            <a:ext cx="4322852" cy="3707935"/>
            <a:chOff x="192530" y="1730078"/>
            <a:chExt cx="2678135" cy="2774185"/>
          </a:xfrm>
        </p:grpSpPr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4265A971-A49A-498B-AB83-10B44C4EA09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0222" y="1983076"/>
              <a:ext cx="1074060" cy="1224000"/>
            </a:xfrm>
            <a:prstGeom prst="rect">
              <a:avLst/>
            </a:prstGeom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57BE82B5-3613-41CA-A9AC-7F8BCDF554E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0222" y="3280263"/>
              <a:ext cx="1074672" cy="1224000"/>
            </a:xfrm>
            <a:prstGeom prst="rect">
              <a:avLst/>
            </a:prstGeom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A671BD0C-E2E6-4D97-BCF3-D509B193665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867" y="1983076"/>
              <a:ext cx="1075211" cy="1224000"/>
            </a:xfrm>
            <a:prstGeom prst="rect">
              <a:avLst/>
            </a:prstGeom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0699E03A-17E9-4664-A484-1E36DB1A355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353" y="3280263"/>
              <a:ext cx="1075211" cy="1224000"/>
            </a:xfrm>
            <a:prstGeom prst="rect">
              <a:avLst/>
            </a:prstGeom>
          </p:spPr>
        </p:pic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62E17E84-468F-4A8A-87C8-D3698D0790C7}"/>
                </a:ext>
              </a:extLst>
            </p:cNvPr>
            <p:cNvSpPr txBox="1"/>
            <p:nvPr/>
          </p:nvSpPr>
          <p:spPr>
            <a:xfrm>
              <a:off x="1866646" y="1745034"/>
              <a:ext cx="10040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i="1" dirty="0" err="1"/>
                <a:t>Otulin</a:t>
              </a:r>
              <a:r>
                <a:rPr lang="nl-NL" sz="1200" i="1" baseline="30000" dirty="0" err="1"/>
                <a:t>IEC</a:t>
              </a:r>
              <a:r>
                <a:rPr lang="nl-NL" sz="1200" i="1" baseline="30000" dirty="0"/>
                <a:t>-KO</a:t>
              </a:r>
              <a:endParaRPr lang="en-US" sz="1200" i="1" dirty="0"/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2A19CF39-4B72-43D5-82A1-79A08EEB7306}"/>
                </a:ext>
              </a:extLst>
            </p:cNvPr>
            <p:cNvSpPr txBox="1"/>
            <p:nvPr/>
          </p:nvSpPr>
          <p:spPr>
            <a:xfrm>
              <a:off x="756922" y="1730078"/>
              <a:ext cx="4207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WT</a:t>
              </a:r>
              <a:endParaRPr lang="en-BE" sz="1200" dirty="0"/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F9BC6730-C994-4DBD-B13F-6378A62AD380}"/>
                </a:ext>
              </a:extLst>
            </p:cNvPr>
            <p:cNvSpPr txBox="1"/>
            <p:nvPr/>
          </p:nvSpPr>
          <p:spPr>
            <a:xfrm rot="16200000">
              <a:off x="-66669" y="2456577"/>
              <a:ext cx="795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Proximal</a:t>
              </a:r>
              <a:endParaRPr lang="en-BE" sz="1200" dirty="0"/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948C8B8A-6647-426A-A086-1931D34A9FC2}"/>
                </a:ext>
              </a:extLst>
            </p:cNvPr>
            <p:cNvSpPr txBox="1"/>
            <p:nvPr/>
          </p:nvSpPr>
          <p:spPr>
            <a:xfrm rot="16200000">
              <a:off x="-66669" y="3527092"/>
              <a:ext cx="795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Distal</a:t>
              </a:r>
              <a:endParaRPr lang="en-BE" sz="1200" dirty="0"/>
            </a:p>
          </p:txBody>
        </p:sp>
      </p:grpSp>
      <p:graphicFrame>
        <p:nvGraphicFramePr>
          <p:cNvPr id="108" name="Object 107">
            <a:extLst>
              <a:ext uri="{FF2B5EF4-FFF2-40B4-BE49-F238E27FC236}">
                <a16:creationId xmlns:a16="http://schemas.microsoft.com/office/drawing/2014/main" id="{E6F23168-673D-42F1-AE1C-BB7B96B8E0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0593346"/>
              </p:ext>
            </p:extLst>
          </p:nvPr>
        </p:nvGraphicFramePr>
        <p:xfrm>
          <a:off x="5726039" y="3022758"/>
          <a:ext cx="1990725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2" name="Prism 9" r:id="rId7" imgW="3088884" imgH="3069762" progId="Prism9.Document">
                  <p:embed/>
                </p:oleObj>
              </mc:Choice>
              <mc:Fallback>
                <p:oleObj name="Prism 9" r:id="rId7" imgW="3088884" imgH="3069762" progId="Prism9.Document">
                  <p:embed/>
                  <p:pic>
                    <p:nvPicPr>
                      <p:cNvPr id="108" name="Object 107">
                        <a:extLst>
                          <a:ext uri="{FF2B5EF4-FFF2-40B4-BE49-F238E27FC236}">
                            <a16:creationId xmlns:a16="http://schemas.microsoft.com/office/drawing/2014/main" id="{E6F23168-673D-42F1-AE1C-BB7B96B8E0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726039" y="3022758"/>
                        <a:ext cx="1990725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9" name="Object 108">
            <a:extLst>
              <a:ext uri="{FF2B5EF4-FFF2-40B4-BE49-F238E27FC236}">
                <a16:creationId xmlns:a16="http://schemas.microsoft.com/office/drawing/2014/main" id="{C92BFD6F-E750-4535-9811-F4AF29F187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7548081"/>
              </p:ext>
            </p:extLst>
          </p:nvPr>
        </p:nvGraphicFramePr>
        <p:xfrm>
          <a:off x="5724452" y="1083299"/>
          <a:ext cx="1992312" cy="1889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3" name="Prism 9" r:id="rId9" imgW="3058272" imgH="2903780" progId="Prism9.Document">
                  <p:embed/>
                </p:oleObj>
              </mc:Choice>
              <mc:Fallback>
                <p:oleObj name="Prism 9" r:id="rId9" imgW="3058272" imgH="2903780" progId="Prism9.Document">
                  <p:embed/>
                  <p:pic>
                    <p:nvPicPr>
                      <p:cNvPr id="109" name="Object 108">
                        <a:extLst>
                          <a:ext uri="{FF2B5EF4-FFF2-40B4-BE49-F238E27FC236}">
                            <a16:creationId xmlns:a16="http://schemas.microsoft.com/office/drawing/2014/main" id="{C92BFD6F-E750-4535-9811-F4AF29F187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724452" y="1083299"/>
                        <a:ext cx="1992312" cy="1889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95D0B573-797D-4D53-9601-67BEBDC587BC}"/>
              </a:ext>
            </a:extLst>
          </p:cNvPr>
          <p:cNvSpPr txBox="1"/>
          <p:nvPr/>
        </p:nvSpPr>
        <p:spPr>
          <a:xfrm>
            <a:off x="5569333" y="1022163"/>
            <a:ext cx="4033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B</a:t>
            </a:r>
            <a:endParaRPr lang="en-BE" sz="16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0E2677-1879-4935-9575-F77851A28712}"/>
              </a:ext>
            </a:extLst>
          </p:cNvPr>
          <p:cNvSpPr txBox="1"/>
          <p:nvPr/>
        </p:nvSpPr>
        <p:spPr>
          <a:xfrm>
            <a:off x="805343" y="5360565"/>
            <a:ext cx="1093085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4. TNF induces IEC apoptosis and lethality in OTULIN</a:t>
            </a:r>
            <a:r>
              <a:rPr lang="en-US" sz="1200" b="1" baseline="30000" dirty="0"/>
              <a:t>IEC-KO</a:t>
            </a:r>
            <a:r>
              <a:rPr lang="en-US" sz="1200" i="1" dirty="0"/>
              <a:t> </a:t>
            </a:r>
            <a:r>
              <a:rPr lang="en-US" sz="1200" b="1" dirty="0"/>
              <a:t>mice</a:t>
            </a:r>
            <a:r>
              <a:rPr lang="en-US" sz="1200" dirty="0"/>
              <a:t>.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and control littermate mice were injected intraperitoneally with 5 µg of recombinant mouse TNF per 20 g body weight.</a:t>
            </a:r>
            <a:r>
              <a:rPr lang="en-US" sz="1200" i="1" dirty="0"/>
              <a:t> </a:t>
            </a:r>
            <a:r>
              <a:rPr lang="en-US" sz="1200" dirty="0"/>
              <a:t>(A) Representative images of cleaved caspase-3-stained sections of the proximal and distal colon of 8-15-week old WT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mice 4 hours after TNF injection. Scale bar, 200 </a:t>
            </a:r>
            <a:r>
              <a:rPr lang="el-GR" sz="1200" dirty="0"/>
              <a:t>μ</a:t>
            </a:r>
            <a:r>
              <a:rPr lang="en-US" sz="1200" dirty="0"/>
              <a:t>m. (B) Quantification of the number of cleaved caspase-3-positive staining in proximal and distal colon of 8-15-week old WT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mice  (n = 5)  4 hours after TNF injection. Data are represented as mean ± SEM. * p&lt; 0,05.</a:t>
            </a:r>
            <a:endParaRPr lang="en-BE" sz="1200" dirty="0"/>
          </a:p>
          <a:p>
            <a:endParaRPr lang="en-BE" sz="1200" dirty="0"/>
          </a:p>
        </p:txBody>
      </p:sp>
    </p:spTree>
    <p:extLst>
      <p:ext uri="{BB962C8B-B14F-4D97-AF65-F5344CB8AC3E}">
        <p14:creationId xmlns:p14="http://schemas.microsoft.com/office/powerpoint/2010/main" val="8163115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7E34B6A-97E0-4E11-A1E6-676035F93EA0}"/>
              </a:ext>
            </a:extLst>
          </p:cNvPr>
          <p:cNvSpPr txBox="1"/>
          <p:nvPr/>
        </p:nvSpPr>
        <p:spPr>
          <a:xfrm>
            <a:off x="1364422" y="1571116"/>
            <a:ext cx="31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A</a:t>
            </a:r>
            <a:endParaRPr lang="en-BE" sz="1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2D8B52-F529-46C2-81A7-C031B1F4A1EA}"/>
              </a:ext>
            </a:extLst>
          </p:cNvPr>
          <p:cNvSpPr txBox="1"/>
          <p:nvPr/>
        </p:nvSpPr>
        <p:spPr>
          <a:xfrm>
            <a:off x="5408725" y="1570398"/>
            <a:ext cx="315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600" b="1" dirty="0"/>
              <a:t>B</a:t>
            </a:r>
            <a:endParaRPr lang="en-BE" sz="1600" b="1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784799E-5267-4713-A13C-E5D1A7F47233}"/>
              </a:ext>
            </a:extLst>
          </p:cNvPr>
          <p:cNvGrpSpPr/>
          <p:nvPr/>
        </p:nvGrpSpPr>
        <p:grpSpPr>
          <a:xfrm>
            <a:off x="1304714" y="1696300"/>
            <a:ext cx="4011888" cy="3465400"/>
            <a:chOff x="1264788" y="1410345"/>
            <a:chExt cx="4011888" cy="3465400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6EF11AE4-DE04-41ED-822E-7CC8033EC2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5" t="17716" r="8505" b="72973"/>
            <a:stretch/>
          </p:blipFill>
          <p:spPr>
            <a:xfrm>
              <a:off x="1828799" y="3181435"/>
              <a:ext cx="2474753" cy="3817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739B180-87AB-48E8-92E5-59A92B2B5D8E}"/>
                </a:ext>
              </a:extLst>
            </p:cNvPr>
            <p:cNvSpPr txBox="1"/>
            <p:nvPr/>
          </p:nvSpPr>
          <p:spPr>
            <a:xfrm>
              <a:off x="1435363" y="3410741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21FB60B-C837-4188-892A-6230AB07E367}"/>
                </a:ext>
              </a:extLst>
            </p:cNvPr>
            <p:cNvSpPr txBox="1"/>
            <p:nvPr/>
          </p:nvSpPr>
          <p:spPr>
            <a:xfrm>
              <a:off x="1435363" y="3181435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50 -</a:t>
              </a:r>
              <a:endParaRPr lang="en-BE" sz="12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5ABA2BE-F16E-452D-BB98-DB6681E2CB5A}"/>
                </a:ext>
              </a:extLst>
            </p:cNvPr>
            <p:cNvSpPr txBox="1"/>
            <p:nvPr/>
          </p:nvSpPr>
          <p:spPr>
            <a:xfrm>
              <a:off x="4304950" y="3214991"/>
              <a:ext cx="587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P-JNK</a:t>
              </a:r>
              <a:endParaRPr lang="en-BE" sz="12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25044D4-59C3-49A1-913D-AA6191F4E965}"/>
                </a:ext>
              </a:extLst>
            </p:cNvPr>
            <p:cNvSpPr txBox="1"/>
            <p:nvPr/>
          </p:nvSpPr>
          <p:spPr>
            <a:xfrm>
              <a:off x="4304950" y="3661006"/>
              <a:ext cx="587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JNK</a:t>
              </a:r>
              <a:endParaRPr lang="en-BE" sz="1200" dirty="0"/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9AE3B05-1188-476B-A160-9F3B4F1A26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76" t="25861" r="8833" b="70456"/>
            <a:stretch/>
          </p:blipFill>
          <p:spPr>
            <a:xfrm>
              <a:off x="1828799" y="1921078"/>
              <a:ext cx="2474754" cy="1510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901DECE-5358-44B7-AB1F-E47E4519C34C}"/>
                </a:ext>
              </a:extLst>
            </p:cNvPr>
            <p:cNvSpPr txBox="1"/>
            <p:nvPr/>
          </p:nvSpPr>
          <p:spPr>
            <a:xfrm>
              <a:off x="1435363" y="1860589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06444D2-5B06-46E5-814B-DA72406628B4}"/>
                </a:ext>
              </a:extLst>
            </p:cNvPr>
            <p:cNvSpPr txBox="1"/>
            <p:nvPr/>
          </p:nvSpPr>
          <p:spPr>
            <a:xfrm>
              <a:off x="4304950" y="1860589"/>
              <a:ext cx="759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P-</a:t>
              </a:r>
              <a:r>
                <a:rPr lang="nl-BE" sz="1200" dirty="0" err="1"/>
                <a:t>I</a:t>
              </a:r>
              <a:r>
                <a:rPr lang="nl-BE" sz="1200" dirty="0" err="1">
                  <a:latin typeface="Symbol" panose="05050102010706020507" pitchFamily="18" charset="2"/>
                </a:rPr>
                <a:t>k</a:t>
              </a:r>
              <a:r>
                <a:rPr lang="nl-BE" sz="1200" dirty="0" err="1"/>
                <a:t>B</a:t>
              </a:r>
              <a:r>
                <a:rPr lang="nl-BE" sz="1200" dirty="0" err="1">
                  <a:latin typeface="Symbol" panose="05050102010706020507" pitchFamily="18" charset="2"/>
                </a:rPr>
                <a:t>a</a:t>
              </a:r>
              <a:endParaRPr lang="en-BE" sz="1200" dirty="0">
                <a:latin typeface="Symbol" panose="05050102010706020507" pitchFamily="18" charset="2"/>
              </a:endParaRP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65AC3EC-4958-4A92-8AE1-F36448766B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27" t="72382" r="8583" b="20265"/>
            <a:stretch/>
          </p:blipFill>
          <p:spPr>
            <a:xfrm>
              <a:off x="1828799" y="4123674"/>
              <a:ext cx="2474754" cy="3015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978C5B1-6FC4-4E9D-8D21-6B2F834286B8}"/>
                </a:ext>
              </a:extLst>
            </p:cNvPr>
            <p:cNvSpPr txBox="1"/>
            <p:nvPr/>
          </p:nvSpPr>
          <p:spPr>
            <a:xfrm>
              <a:off x="1435363" y="4148194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2E6C728-C8F8-4866-BE15-AFC4F815F6C3}"/>
                </a:ext>
              </a:extLst>
            </p:cNvPr>
            <p:cNvSpPr txBox="1"/>
            <p:nvPr/>
          </p:nvSpPr>
          <p:spPr>
            <a:xfrm>
              <a:off x="4304950" y="4146409"/>
              <a:ext cx="8542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OTULIN</a:t>
              </a:r>
              <a:endParaRPr lang="en-BE" sz="12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ABB10DE-AD50-43B0-B1E8-157B12945992}"/>
                </a:ext>
              </a:extLst>
            </p:cNvPr>
            <p:cNvSpPr txBox="1"/>
            <p:nvPr/>
          </p:nvSpPr>
          <p:spPr>
            <a:xfrm>
              <a:off x="1809000" y="1644079"/>
              <a:ext cx="2828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0   5  15  30 45 60   0   5   15 30 45  60</a:t>
              </a:r>
              <a:endParaRPr lang="en-BE" sz="12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5E3E366-B0C4-4503-A69D-FA56B769A5C8}"/>
                </a:ext>
              </a:extLst>
            </p:cNvPr>
            <p:cNvSpPr txBox="1"/>
            <p:nvPr/>
          </p:nvSpPr>
          <p:spPr>
            <a:xfrm>
              <a:off x="2345846" y="1410345"/>
              <a:ext cx="4141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WT</a:t>
              </a:r>
              <a:endParaRPr lang="en-BE" sz="12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BB77695-C1EF-48CB-9130-3A1923EC71A8}"/>
                </a:ext>
              </a:extLst>
            </p:cNvPr>
            <p:cNvSpPr txBox="1"/>
            <p:nvPr/>
          </p:nvSpPr>
          <p:spPr>
            <a:xfrm>
              <a:off x="3144197" y="1410345"/>
              <a:ext cx="9302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OTULIN-KO</a:t>
              </a:r>
              <a:endParaRPr lang="en-BE" sz="1200" dirty="0"/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6FCA943D-B4C2-4D59-934E-CFAA0BBB39FD}"/>
                </a:ext>
              </a:extLst>
            </p:cNvPr>
            <p:cNvCxnSpPr/>
            <p:nvPr/>
          </p:nvCxnSpPr>
          <p:spPr>
            <a:xfrm>
              <a:off x="1924996" y="1644079"/>
              <a:ext cx="109504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5FA1993D-95FB-4527-8AC4-193A2EAF2813}"/>
                </a:ext>
              </a:extLst>
            </p:cNvPr>
            <p:cNvCxnSpPr/>
            <p:nvPr/>
          </p:nvCxnSpPr>
          <p:spPr>
            <a:xfrm>
              <a:off x="3092465" y="1645477"/>
              <a:ext cx="109504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D69940BA-33BA-47F8-8A72-0CC0D87508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71" t="68104" r="10240" b="21317"/>
            <a:stretch/>
          </p:blipFill>
          <p:spPr>
            <a:xfrm>
              <a:off x="1828799" y="3634989"/>
              <a:ext cx="2474753" cy="4337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558CAFF-19D6-442E-8B8A-E4DC33390CD2}"/>
                </a:ext>
              </a:extLst>
            </p:cNvPr>
            <p:cNvSpPr txBox="1"/>
            <p:nvPr/>
          </p:nvSpPr>
          <p:spPr>
            <a:xfrm>
              <a:off x="1435363" y="3864295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6A76990-9B05-4333-B1A7-B058625CF05F}"/>
                </a:ext>
              </a:extLst>
            </p:cNvPr>
            <p:cNvSpPr txBox="1"/>
            <p:nvPr/>
          </p:nvSpPr>
          <p:spPr>
            <a:xfrm>
              <a:off x="1435363" y="3634989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50 -</a:t>
              </a:r>
              <a:endParaRPr lang="en-BE" sz="1200" dirty="0"/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5CCA7992-2510-426D-ADE3-F3D079380B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33" t="22714" r="9677" b="69431"/>
            <a:stretch/>
          </p:blipFill>
          <p:spPr>
            <a:xfrm>
              <a:off x="1828799" y="2803561"/>
              <a:ext cx="2474753" cy="3221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66FF868-D9F9-4712-8E71-8B5E2E077036}"/>
                </a:ext>
              </a:extLst>
            </p:cNvPr>
            <p:cNvSpPr txBox="1"/>
            <p:nvPr/>
          </p:nvSpPr>
          <p:spPr>
            <a:xfrm>
              <a:off x="1435363" y="2848676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0B668C0-60C8-4BBB-B6D5-E60A2177CC26}"/>
                </a:ext>
              </a:extLst>
            </p:cNvPr>
            <p:cNvSpPr txBox="1"/>
            <p:nvPr/>
          </p:nvSpPr>
          <p:spPr>
            <a:xfrm>
              <a:off x="4304950" y="2474791"/>
              <a:ext cx="587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P-p38</a:t>
              </a:r>
              <a:endParaRPr lang="en-BE" sz="12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8A92A36-8AD5-41D2-8E1E-D56F51354D17}"/>
                </a:ext>
              </a:extLst>
            </p:cNvPr>
            <p:cNvSpPr txBox="1"/>
            <p:nvPr/>
          </p:nvSpPr>
          <p:spPr>
            <a:xfrm>
              <a:off x="4304950" y="2785262"/>
              <a:ext cx="587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p38</a:t>
              </a:r>
              <a:endParaRPr lang="en-BE" sz="1200" dirty="0"/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330EBCDE-518B-4D87-83BE-3C08FC0EB6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71" t="42686" r="10240" b="51635"/>
            <a:stretch/>
          </p:blipFill>
          <p:spPr>
            <a:xfrm>
              <a:off x="1828799" y="2148242"/>
              <a:ext cx="2474754" cy="2328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A167FCB-D910-4BFE-BE6A-3E2EC2FC6BAE}"/>
                </a:ext>
              </a:extLst>
            </p:cNvPr>
            <p:cNvSpPr txBox="1"/>
            <p:nvPr/>
          </p:nvSpPr>
          <p:spPr>
            <a:xfrm>
              <a:off x="1435363" y="2072246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293BCAB-5DC3-48E5-90E4-F215608141EA}"/>
                </a:ext>
              </a:extLst>
            </p:cNvPr>
            <p:cNvSpPr txBox="1"/>
            <p:nvPr/>
          </p:nvSpPr>
          <p:spPr>
            <a:xfrm>
              <a:off x="4304950" y="2121673"/>
              <a:ext cx="587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I</a:t>
              </a:r>
              <a:r>
                <a:rPr lang="nl-BE" sz="1200" dirty="0" err="1">
                  <a:latin typeface="Symbol" panose="05050102010706020507" pitchFamily="18" charset="2"/>
                </a:rPr>
                <a:t>k</a:t>
              </a:r>
              <a:r>
                <a:rPr lang="nl-BE" sz="1200" dirty="0" err="1"/>
                <a:t>B</a:t>
              </a:r>
              <a:r>
                <a:rPr lang="nl-BE" sz="1200" dirty="0" err="1">
                  <a:latin typeface="Symbol" panose="05050102010706020507" pitchFamily="18" charset="2"/>
                </a:rPr>
                <a:t>a</a:t>
              </a:r>
              <a:endParaRPr lang="en-BE" sz="1200" dirty="0">
                <a:latin typeface="Symbol" panose="05050102010706020507" pitchFamily="18" charset="2"/>
              </a:endParaRP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EF63A00A-F867-4103-8BEC-C916EAA7E6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23" t="43347" r="9386" b="49494"/>
            <a:stretch/>
          </p:blipFill>
          <p:spPr>
            <a:xfrm>
              <a:off x="1828799" y="2448570"/>
              <a:ext cx="2474754" cy="2934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1C44EA1-4A0A-4491-BF56-1C5BBE24C425}"/>
                </a:ext>
              </a:extLst>
            </p:cNvPr>
            <p:cNvSpPr txBox="1"/>
            <p:nvPr/>
          </p:nvSpPr>
          <p:spPr>
            <a:xfrm>
              <a:off x="1435363" y="2465068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DD8FF22-C2AA-4BF7-9AEB-A818A4A9BBD3}"/>
                </a:ext>
              </a:extLst>
            </p:cNvPr>
            <p:cNvSpPr txBox="1"/>
            <p:nvPr/>
          </p:nvSpPr>
          <p:spPr>
            <a:xfrm>
              <a:off x="4304950" y="4504969"/>
              <a:ext cx="8542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Actin</a:t>
              </a:r>
              <a:endParaRPr lang="en-BE" sz="1200" dirty="0"/>
            </a:p>
          </p:txBody>
        </p: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70D2DA08-7262-4A3F-9399-D5AEC5258C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73" t="47140" r="11436" b="46473"/>
            <a:stretch/>
          </p:blipFill>
          <p:spPr>
            <a:xfrm>
              <a:off x="1828799" y="4480826"/>
              <a:ext cx="2474754" cy="2619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9615810-7FB4-4AC4-99D6-77C45DDD6A83}"/>
                </a:ext>
              </a:extLst>
            </p:cNvPr>
            <p:cNvSpPr txBox="1"/>
            <p:nvPr/>
          </p:nvSpPr>
          <p:spPr>
            <a:xfrm>
              <a:off x="1435363" y="4598746"/>
              <a:ext cx="46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37 -</a:t>
              </a:r>
              <a:endParaRPr lang="en-BE" sz="1200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F349CD0-77BB-417C-A397-5AC97592F35A}"/>
                </a:ext>
              </a:extLst>
            </p:cNvPr>
            <p:cNvSpPr txBox="1"/>
            <p:nvPr/>
          </p:nvSpPr>
          <p:spPr>
            <a:xfrm>
              <a:off x="4319779" y="1644079"/>
              <a:ext cx="9568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hTNF</a:t>
              </a:r>
              <a:r>
                <a:rPr lang="nl-BE" sz="1200" dirty="0"/>
                <a:t> (min) </a:t>
              </a:r>
              <a:endParaRPr lang="en-BE" sz="12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51296C8-BF87-43DE-9546-D392186418B0}"/>
                </a:ext>
              </a:extLst>
            </p:cNvPr>
            <p:cNvSpPr txBox="1"/>
            <p:nvPr/>
          </p:nvSpPr>
          <p:spPr>
            <a:xfrm>
              <a:off x="1264788" y="1651595"/>
              <a:ext cx="587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kDa</a:t>
              </a:r>
              <a:endParaRPr lang="en-BE" sz="1200" dirty="0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48DF80B8-CDEC-4884-AF71-27160D5A88CE}"/>
              </a:ext>
            </a:extLst>
          </p:cNvPr>
          <p:cNvGrpSpPr/>
          <p:nvPr/>
        </p:nvGrpSpPr>
        <p:grpSpPr>
          <a:xfrm>
            <a:off x="5347346" y="1699855"/>
            <a:ext cx="4141022" cy="3389899"/>
            <a:chOff x="6109206" y="1771801"/>
            <a:chExt cx="4141022" cy="3389899"/>
          </a:xfrm>
        </p:grpSpPr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20211C8C-C60E-44CA-997C-228F1C8B8E94}"/>
                </a:ext>
              </a:extLst>
            </p:cNvPr>
            <p:cNvGrpSpPr/>
            <p:nvPr/>
          </p:nvGrpSpPr>
          <p:grpSpPr>
            <a:xfrm>
              <a:off x="6109206" y="1771801"/>
              <a:ext cx="4141022" cy="3389899"/>
              <a:chOff x="1525034" y="2050133"/>
              <a:chExt cx="3721339" cy="3096627"/>
            </a:xfrm>
          </p:grpSpPr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175E306C-6669-49C6-BE03-552C48B103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837" t="33373" r="11927" b="60073"/>
              <a:stretch/>
            </p:blipFill>
            <p:spPr>
              <a:xfrm>
                <a:off x="2080467" y="4450206"/>
                <a:ext cx="2004971" cy="26872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2651B25A-9C53-4D60-BC1A-3CF00417678A}"/>
                  </a:ext>
                </a:extLst>
              </p:cNvPr>
              <p:cNvSpPr txBox="1"/>
              <p:nvPr/>
            </p:nvSpPr>
            <p:spPr>
              <a:xfrm>
                <a:off x="1694575" y="4588777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DA1EDFE-A063-49E1-9B5C-61270B54F421}"/>
                  </a:ext>
                </a:extLst>
              </p:cNvPr>
              <p:cNvSpPr txBox="1"/>
              <p:nvPr/>
            </p:nvSpPr>
            <p:spPr>
              <a:xfrm>
                <a:off x="4127384" y="4471331"/>
                <a:ext cx="788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OTULIN</a:t>
                </a:r>
                <a:endParaRPr lang="en-BE" sz="1200" dirty="0"/>
              </a:p>
            </p:txBody>
          </p:sp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C305AA8A-1515-4A34-B9AF-DA4C11BC1B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21" t="40913" r="19543" b="52453"/>
              <a:stretch/>
            </p:blipFill>
            <p:spPr>
              <a:xfrm>
                <a:off x="2080470" y="2516320"/>
                <a:ext cx="2004970" cy="27195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316AB1CB-A5A2-4738-8AA6-0C0961361646}"/>
                  </a:ext>
                </a:extLst>
              </p:cNvPr>
              <p:cNvSpPr txBox="1"/>
              <p:nvPr/>
            </p:nvSpPr>
            <p:spPr>
              <a:xfrm>
                <a:off x="1694575" y="2521880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670E65F3-981E-4876-AD1F-3AE21CF899FB}"/>
                  </a:ext>
                </a:extLst>
              </p:cNvPr>
              <p:cNvSpPr txBox="1"/>
              <p:nvPr/>
            </p:nvSpPr>
            <p:spPr>
              <a:xfrm>
                <a:off x="4127384" y="3665910"/>
                <a:ext cx="788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P-JNK</a:t>
                </a:r>
                <a:endParaRPr lang="en-BE" sz="1200" dirty="0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EAB4F80B-8E31-4BAF-88E5-0AFC44A4C53A}"/>
                  </a:ext>
                </a:extLst>
              </p:cNvPr>
              <p:cNvSpPr txBox="1"/>
              <p:nvPr/>
            </p:nvSpPr>
            <p:spPr>
              <a:xfrm>
                <a:off x="4127384" y="4065024"/>
                <a:ext cx="788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JNK</a:t>
                </a:r>
                <a:endParaRPr lang="en-BE" sz="1200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544C04B0-9C2C-4083-9E35-1449920FABDD}"/>
                  </a:ext>
                </a:extLst>
              </p:cNvPr>
              <p:cNvSpPr txBox="1"/>
              <p:nvPr/>
            </p:nvSpPr>
            <p:spPr>
              <a:xfrm>
                <a:off x="4127384" y="3124873"/>
                <a:ext cx="788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P-p38</a:t>
                </a:r>
                <a:endParaRPr lang="en-BE" sz="1200" dirty="0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7EDF3973-8AD6-4DA5-BC25-DEC74022068F}"/>
                  </a:ext>
                </a:extLst>
              </p:cNvPr>
              <p:cNvSpPr txBox="1"/>
              <p:nvPr/>
            </p:nvSpPr>
            <p:spPr>
              <a:xfrm>
                <a:off x="4127384" y="3342346"/>
                <a:ext cx="788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p38</a:t>
                </a:r>
                <a:endParaRPr lang="en-BE" sz="1200" dirty="0"/>
              </a:p>
            </p:txBody>
          </p:sp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8BC87844-B1EB-4EB6-BB1A-9DA304DB5B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09" t="35039" r="22356" b="58585"/>
              <a:stretch/>
            </p:blipFill>
            <p:spPr>
              <a:xfrm>
                <a:off x="2080469" y="2829772"/>
                <a:ext cx="2004971" cy="26139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0F64EBA2-8E60-4805-8403-50F0D26416FD}"/>
                  </a:ext>
                </a:extLst>
              </p:cNvPr>
              <p:cNvSpPr txBox="1"/>
              <p:nvPr/>
            </p:nvSpPr>
            <p:spPr>
              <a:xfrm>
                <a:off x="1694575" y="2832886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A2A5854B-2662-4758-A29A-180872847C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92" t="36421" r="17272" b="55838"/>
              <a:stretch/>
            </p:blipFill>
            <p:spPr>
              <a:xfrm>
                <a:off x="2080467" y="3663488"/>
                <a:ext cx="2004971" cy="3179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D5C18F5-3F0D-4BD6-9929-B373BAEB2101}"/>
                  </a:ext>
                </a:extLst>
              </p:cNvPr>
              <p:cNvSpPr txBox="1"/>
              <p:nvPr/>
            </p:nvSpPr>
            <p:spPr>
              <a:xfrm>
                <a:off x="1694575" y="3791985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9DFB3AF5-F0A0-4689-8CED-A33E3F3072CC}"/>
                  </a:ext>
                </a:extLst>
              </p:cNvPr>
              <p:cNvSpPr txBox="1"/>
              <p:nvPr/>
            </p:nvSpPr>
            <p:spPr>
              <a:xfrm>
                <a:off x="1694575" y="3609443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50 -</a:t>
                </a:r>
                <a:endParaRPr lang="en-BE" sz="1200" dirty="0"/>
              </a:p>
            </p:txBody>
          </p:sp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D0FBE7FE-DEDF-40A8-A746-0177208B50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66" t="39104" r="18399" b="52640"/>
              <a:stretch/>
            </p:blipFill>
            <p:spPr>
              <a:xfrm>
                <a:off x="2080467" y="4038189"/>
                <a:ext cx="2004971" cy="3384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8270F692-EC54-4835-B4F7-7940D386577E}"/>
                  </a:ext>
                </a:extLst>
              </p:cNvPr>
              <p:cNvSpPr txBox="1"/>
              <p:nvPr/>
            </p:nvSpPr>
            <p:spPr>
              <a:xfrm>
                <a:off x="1694575" y="4174384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444B179A-D5AD-4A31-8FCB-0637ED144C63}"/>
                  </a:ext>
                </a:extLst>
              </p:cNvPr>
              <p:cNvSpPr txBox="1"/>
              <p:nvPr/>
            </p:nvSpPr>
            <p:spPr>
              <a:xfrm>
                <a:off x="1694575" y="3968935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50 -</a:t>
                </a:r>
                <a:endParaRPr lang="en-BE" sz="1200" dirty="0"/>
              </a:p>
            </p:txBody>
          </p:sp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73F25DEA-B2C2-4C45-BCEC-DA11DB27E4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68" t="44881" r="30195" b="50814"/>
              <a:stretch/>
            </p:blipFill>
            <p:spPr>
              <a:xfrm>
                <a:off x="2080470" y="3148299"/>
                <a:ext cx="2004970" cy="17655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45BEE964-C889-436C-BB34-460CFBD0BC84}"/>
                  </a:ext>
                </a:extLst>
              </p:cNvPr>
              <p:cNvSpPr txBox="1"/>
              <p:nvPr/>
            </p:nvSpPr>
            <p:spPr>
              <a:xfrm>
                <a:off x="1694575" y="3152555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C43D3769-0B23-4A10-BF93-4A7F16E9C4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510" t="41257" r="17254" b="52846"/>
              <a:stretch/>
            </p:blipFill>
            <p:spPr>
              <a:xfrm>
                <a:off x="2080468" y="3375708"/>
                <a:ext cx="2004971" cy="24183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A3D66B44-7A7C-40F8-B492-C16094A0857E}"/>
                  </a:ext>
                </a:extLst>
              </p:cNvPr>
              <p:cNvSpPr txBox="1"/>
              <p:nvPr/>
            </p:nvSpPr>
            <p:spPr>
              <a:xfrm>
                <a:off x="1694575" y="3415268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pic>
            <p:nvPicPr>
              <p:cNvPr id="77" name="Picture 76">
                <a:extLst>
                  <a:ext uri="{FF2B5EF4-FFF2-40B4-BE49-F238E27FC236}">
                    <a16:creationId xmlns:a16="http://schemas.microsoft.com/office/drawing/2014/main" id="{24151497-337E-446A-AD6A-E416087D8C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96" t="43244" r="11169" b="51364"/>
              <a:stretch/>
            </p:blipFill>
            <p:spPr>
              <a:xfrm>
                <a:off x="2080467" y="4789987"/>
                <a:ext cx="2004971" cy="22106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1595B3F7-531A-46F4-82F7-6DC47031F072}"/>
                  </a:ext>
                </a:extLst>
              </p:cNvPr>
              <p:cNvSpPr txBox="1"/>
              <p:nvPr/>
            </p:nvSpPr>
            <p:spPr>
              <a:xfrm>
                <a:off x="1694575" y="4869761"/>
                <a:ext cx="503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37 -</a:t>
                </a:r>
                <a:endParaRPr lang="en-BE" sz="1200" dirty="0"/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BE04F178-13E0-46A5-825B-58C1BF4E9E59}"/>
                  </a:ext>
                </a:extLst>
              </p:cNvPr>
              <p:cNvSpPr txBox="1"/>
              <p:nvPr/>
            </p:nvSpPr>
            <p:spPr>
              <a:xfrm>
                <a:off x="4127384" y="4770456"/>
                <a:ext cx="788565" cy="253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 err="1"/>
                  <a:t>Actin</a:t>
                </a:r>
                <a:endParaRPr lang="en-BE" sz="1200" dirty="0"/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6FA7B3EE-F200-4C22-A6AC-1E7764CD7408}"/>
                  </a:ext>
                </a:extLst>
              </p:cNvPr>
              <p:cNvSpPr txBox="1"/>
              <p:nvPr/>
            </p:nvSpPr>
            <p:spPr>
              <a:xfrm>
                <a:off x="2080469" y="2285670"/>
                <a:ext cx="2334100" cy="253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0  30  60  90 120  0  30  60 90 120</a:t>
                </a:r>
                <a:endParaRPr lang="en-BE" sz="1200" dirty="0"/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F98C5F36-A1D3-436A-9986-E0B5B3F005AC}"/>
                  </a:ext>
                </a:extLst>
              </p:cNvPr>
              <p:cNvSpPr txBox="1"/>
              <p:nvPr/>
            </p:nvSpPr>
            <p:spPr>
              <a:xfrm>
                <a:off x="3992608" y="2248300"/>
                <a:ext cx="12537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MDP-L18 (min)</a:t>
                </a:r>
                <a:endParaRPr lang="en-BE" sz="1200" dirty="0"/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89F8A11E-3608-44B5-97AF-B596B534CEA8}"/>
                  </a:ext>
                </a:extLst>
              </p:cNvPr>
              <p:cNvSpPr txBox="1"/>
              <p:nvPr/>
            </p:nvSpPr>
            <p:spPr>
              <a:xfrm>
                <a:off x="2436569" y="2050133"/>
                <a:ext cx="4620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WT</a:t>
                </a:r>
                <a:endParaRPr lang="en-BE" sz="1200" dirty="0"/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6BD7005D-77B8-4817-9D9F-46AA026387DF}"/>
                  </a:ext>
                </a:extLst>
              </p:cNvPr>
              <p:cNvSpPr txBox="1"/>
              <p:nvPr/>
            </p:nvSpPr>
            <p:spPr>
              <a:xfrm>
                <a:off x="3133943" y="2050133"/>
                <a:ext cx="1253765" cy="2530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/>
                  <a:t>OTULIN-KO</a:t>
                </a:r>
                <a:endParaRPr lang="en-BE" sz="1200" dirty="0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E0C5EA1A-4BED-46D5-860E-03D341864F12}"/>
                  </a:ext>
                </a:extLst>
              </p:cNvPr>
              <p:cNvSpPr txBox="1"/>
              <p:nvPr/>
            </p:nvSpPr>
            <p:spPr>
              <a:xfrm>
                <a:off x="1525034" y="2258165"/>
                <a:ext cx="4620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sz="1200" dirty="0" err="1"/>
                  <a:t>kDa</a:t>
                </a:r>
                <a:endParaRPr lang="en-BE" sz="1200" dirty="0"/>
              </a:p>
            </p:txBody>
          </p: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6D321A17-1DB7-48B2-9B5F-9492D7D35B37}"/>
                  </a:ext>
                </a:extLst>
              </p:cNvPr>
              <p:cNvCxnSpPr/>
              <p:nvPr/>
            </p:nvCxnSpPr>
            <p:spPr>
              <a:xfrm>
                <a:off x="2148154" y="2256767"/>
                <a:ext cx="90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C0A3D35D-97BF-4CDA-859A-B7036C323319}"/>
                  </a:ext>
                </a:extLst>
              </p:cNvPr>
              <p:cNvCxnSpPr/>
              <p:nvPr/>
            </p:nvCxnSpPr>
            <p:spPr>
              <a:xfrm>
                <a:off x="3122676" y="2258165"/>
                <a:ext cx="9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70BC2A92-0757-4F62-8D13-A56A47E0D3DB}"/>
                </a:ext>
              </a:extLst>
            </p:cNvPr>
            <p:cNvSpPr txBox="1"/>
            <p:nvPr/>
          </p:nvSpPr>
          <p:spPr>
            <a:xfrm>
              <a:off x="8968646" y="2282013"/>
              <a:ext cx="759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/>
                <a:t>P-</a:t>
              </a:r>
              <a:r>
                <a:rPr lang="nl-BE" sz="1200" dirty="0" err="1"/>
                <a:t>I</a:t>
              </a:r>
              <a:r>
                <a:rPr lang="nl-BE" sz="1200" dirty="0" err="1">
                  <a:latin typeface="Symbol" panose="05050102010706020507" pitchFamily="18" charset="2"/>
                </a:rPr>
                <a:t>k</a:t>
              </a:r>
              <a:r>
                <a:rPr lang="nl-BE" sz="1200" dirty="0" err="1"/>
                <a:t>B</a:t>
              </a:r>
              <a:r>
                <a:rPr lang="nl-BE" sz="1200" dirty="0" err="1">
                  <a:latin typeface="Symbol" panose="05050102010706020507" pitchFamily="18" charset="2"/>
                </a:rPr>
                <a:t>a</a:t>
              </a:r>
              <a:endParaRPr lang="en-BE" sz="1200" dirty="0">
                <a:latin typeface="Symbol" panose="05050102010706020507" pitchFamily="18" charset="2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3789A33E-DD73-40DB-9653-79F49C72A654}"/>
                </a:ext>
              </a:extLst>
            </p:cNvPr>
            <p:cNvSpPr txBox="1"/>
            <p:nvPr/>
          </p:nvSpPr>
          <p:spPr>
            <a:xfrm>
              <a:off x="8968646" y="2592268"/>
              <a:ext cx="759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sz="1200" dirty="0" err="1"/>
                <a:t>I</a:t>
              </a:r>
              <a:r>
                <a:rPr lang="nl-BE" sz="1200" dirty="0" err="1">
                  <a:latin typeface="Symbol" panose="05050102010706020507" pitchFamily="18" charset="2"/>
                </a:rPr>
                <a:t>k</a:t>
              </a:r>
              <a:r>
                <a:rPr lang="nl-BE" sz="1200" dirty="0" err="1"/>
                <a:t>B</a:t>
              </a:r>
              <a:r>
                <a:rPr lang="nl-BE" sz="1200" dirty="0" err="1">
                  <a:latin typeface="Symbol" panose="05050102010706020507" pitchFamily="18" charset="2"/>
                </a:rPr>
                <a:t>a</a:t>
              </a:r>
              <a:endParaRPr lang="en-BE" sz="1200" dirty="0">
                <a:latin typeface="Symbol" panose="05050102010706020507" pitchFamily="18" charset="2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517A156A-E21C-4E2E-BFCE-E7C47406A964}"/>
              </a:ext>
            </a:extLst>
          </p:cNvPr>
          <p:cNvSpPr txBox="1"/>
          <p:nvPr/>
        </p:nvSpPr>
        <p:spPr>
          <a:xfrm>
            <a:off x="620785" y="5519956"/>
            <a:ext cx="1103152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5. TNF and NOD2-induced NF-kB and MAPK signaling in OTULIN deficient HCT116 cells.</a:t>
            </a:r>
            <a:r>
              <a:rPr lang="en-US" sz="1200" dirty="0"/>
              <a:t> (A-B) WT and OTULIN</a:t>
            </a:r>
            <a:r>
              <a:rPr lang="en-US" sz="1200" baseline="30000" dirty="0"/>
              <a:t>KO</a:t>
            </a:r>
            <a:r>
              <a:rPr lang="en-US" sz="1200" dirty="0"/>
              <a:t> HCT116 cells were treated with </a:t>
            </a:r>
            <a:r>
              <a:rPr lang="en-US" sz="1200" dirty="0" err="1"/>
              <a:t>hTNF</a:t>
            </a:r>
            <a:r>
              <a:rPr lang="en-US" sz="1200" dirty="0"/>
              <a:t> (20 ng/mL) (A) or with L18-MDP (1 µg/mL) (B) for the indicated time points. Activation of signaling pathways was </a:t>
            </a:r>
            <a:r>
              <a:rPr lang="en-US" sz="1200" dirty="0" err="1"/>
              <a:t>analysed</a:t>
            </a:r>
            <a:r>
              <a:rPr lang="en-US" sz="1200" dirty="0"/>
              <a:t> using Western blot. Actin was used as loading control. Representative of two independent experiments using two different OTULIN KO clones.</a:t>
            </a:r>
            <a:endParaRPr lang="en-BE" sz="1200" dirty="0"/>
          </a:p>
          <a:p>
            <a:endParaRPr lang="en-BE" sz="1200" dirty="0"/>
          </a:p>
        </p:txBody>
      </p:sp>
    </p:spTree>
    <p:extLst>
      <p:ext uri="{BB962C8B-B14F-4D97-AF65-F5344CB8AC3E}">
        <p14:creationId xmlns:p14="http://schemas.microsoft.com/office/powerpoint/2010/main" val="38733739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814D58E-073A-4FDE-B3AA-81D27773D9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2514" y="126218"/>
            <a:ext cx="8716161" cy="532654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BA782FD-432C-40B5-A961-2183358990CE}"/>
              </a:ext>
            </a:extLst>
          </p:cNvPr>
          <p:cNvSpPr txBox="1"/>
          <p:nvPr/>
        </p:nvSpPr>
        <p:spPr>
          <a:xfrm>
            <a:off x="352338" y="5452761"/>
            <a:ext cx="1167747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6. Infection studies with </a:t>
            </a:r>
            <a:r>
              <a:rPr lang="nl-BE" sz="1200" b="1" dirty="0"/>
              <a:t>Δ</a:t>
            </a:r>
            <a:r>
              <a:rPr lang="en-US" sz="1200" b="1" dirty="0"/>
              <a:t>SPI-1</a:t>
            </a:r>
            <a:r>
              <a:rPr lang="nl-BE" sz="1200" b="1" dirty="0"/>
              <a:t>Δ</a:t>
            </a:r>
            <a:r>
              <a:rPr lang="en-US" sz="1200" b="1" dirty="0"/>
              <a:t>SPI-2 mutant </a:t>
            </a:r>
            <a:r>
              <a:rPr lang="en-US" sz="1200" b="1" i="1" dirty="0"/>
              <a:t>Salmonella.</a:t>
            </a:r>
            <a:r>
              <a:rPr lang="en-US" sz="1200" dirty="0"/>
              <a:t> (A) Quantitative PCR analysis of inflammatory cytokines and chemokines in IEC lysates from the colon of WT (n = 10 untreated, n = 12 </a:t>
            </a:r>
            <a:r>
              <a:rPr lang="en-US" sz="1200" i="1" dirty="0"/>
              <a:t>Salmonella-</a:t>
            </a:r>
            <a:r>
              <a:rPr lang="en-US" sz="1200" dirty="0"/>
              <a:t>infected, n = 6 </a:t>
            </a:r>
            <a:r>
              <a:rPr lang="nl-BE" sz="1200" dirty="0"/>
              <a:t>Δ</a:t>
            </a:r>
            <a:r>
              <a:rPr lang="en-US" sz="1200" dirty="0"/>
              <a:t>SPI-1</a:t>
            </a:r>
            <a:r>
              <a:rPr lang="nl-BE" sz="1200" dirty="0"/>
              <a:t>Δ</a:t>
            </a:r>
            <a:r>
              <a:rPr lang="en-US" sz="1200" dirty="0"/>
              <a:t>SPI-2</a:t>
            </a:r>
            <a:r>
              <a:rPr lang="en-US" sz="1200" b="1" dirty="0"/>
              <a:t> </a:t>
            </a:r>
            <a:r>
              <a:rPr lang="en-US" sz="1200" i="1" dirty="0"/>
              <a:t>Salmonella</a:t>
            </a:r>
            <a:r>
              <a:rPr lang="en-US" sz="1200" dirty="0"/>
              <a:t>-infected)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n = 7 untreated, n = 9 </a:t>
            </a:r>
            <a:r>
              <a:rPr lang="en-US" sz="1200" i="1" dirty="0"/>
              <a:t>Salmonella-</a:t>
            </a:r>
            <a:r>
              <a:rPr lang="en-US" sz="1200" dirty="0"/>
              <a:t>infected, n = 6 </a:t>
            </a:r>
            <a:r>
              <a:rPr lang="nl-BE" sz="1200" dirty="0"/>
              <a:t>Δ</a:t>
            </a:r>
            <a:r>
              <a:rPr lang="en-US" sz="1200" dirty="0"/>
              <a:t>SPI-1</a:t>
            </a:r>
            <a:r>
              <a:rPr lang="nl-BE" sz="1200" dirty="0"/>
              <a:t>Δ</a:t>
            </a:r>
            <a:r>
              <a:rPr lang="en-US" sz="1200" dirty="0"/>
              <a:t>SPI-2</a:t>
            </a:r>
            <a:r>
              <a:rPr lang="en-US" sz="1200" b="1" dirty="0"/>
              <a:t> </a:t>
            </a:r>
            <a:r>
              <a:rPr lang="en-US" sz="1200" i="1" dirty="0"/>
              <a:t>Salmonella-</a:t>
            </a:r>
            <a:r>
              <a:rPr lang="en-US" sz="1200" dirty="0"/>
              <a:t>infected) mice 4 days post infection. Data are represented as mean ± SEM. (B-C) </a:t>
            </a:r>
            <a:r>
              <a:rPr lang="en-US" sz="1200" dirty="0" err="1"/>
              <a:t>Cecal</a:t>
            </a:r>
            <a:r>
              <a:rPr lang="en-US" sz="1200" dirty="0"/>
              <a:t> and spleen weight of WT (n = 16)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n = 12) mice 4 days after </a:t>
            </a:r>
            <a:r>
              <a:rPr lang="en-US" sz="1200" i="1" dirty="0"/>
              <a:t>Salmonella</a:t>
            </a:r>
            <a:r>
              <a:rPr lang="en-US" sz="1200" dirty="0"/>
              <a:t> infection. Data are represented as mean ± SEM. (D) </a:t>
            </a:r>
            <a:r>
              <a:rPr lang="en-US" sz="1200" i="1" dirty="0"/>
              <a:t>Salmonella</a:t>
            </a:r>
            <a:r>
              <a:rPr lang="en-US" sz="1200" dirty="0"/>
              <a:t> burden in the indicated tissue of WT (n = 16)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n = 12) mice day 4 post infection. Data are represented as mean ± SEM. ****p &lt; 0,0001. (E-F) </a:t>
            </a:r>
            <a:r>
              <a:rPr lang="en-US" sz="1200" dirty="0" err="1"/>
              <a:t>Cecal</a:t>
            </a:r>
            <a:r>
              <a:rPr lang="en-US" sz="1200" dirty="0"/>
              <a:t> and spleen weight of WT (n = 8)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(n = 8) mice 4 days post infection with </a:t>
            </a:r>
            <a:r>
              <a:rPr lang="nl-BE" sz="1200" dirty="0"/>
              <a:t>Δ</a:t>
            </a:r>
            <a:r>
              <a:rPr lang="en-US" sz="1200" dirty="0"/>
              <a:t>SPI-1</a:t>
            </a:r>
            <a:r>
              <a:rPr lang="nl-BE" sz="1200" dirty="0"/>
              <a:t>Δ</a:t>
            </a:r>
            <a:r>
              <a:rPr lang="en-US" sz="1200" dirty="0"/>
              <a:t>SPI-2</a:t>
            </a:r>
            <a:r>
              <a:rPr lang="en-US" sz="1200" b="1" dirty="0"/>
              <a:t> </a:t>
            </a:r>
            <a:r>
              <a:rPr lang="en-US" sz="1200" i="1" dirty="0"/>
              <a:t>Salmonella</a:t>
            </a:r>
            <a:r>
              <a:rPr lang="en-US" sz="1200" dirty="0"/>
              <a:t>. Data are represented as mean ± SEM. (G) Representative images of cleaved caspase-3- and TUNEL- stained colon sections from WT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mice 4 days post infection with </a:t>
            </a:r>
            <a:r>
              <a:rPr lang="nl-BE" sz="1200" dirty="0"/>
              <a:t>Δ</a:t>
            </a:r>
            <a:r>
              <a:rPr lang="en-US" sz="1200" dirty="0"/>
              <a:t>SPI-1</a:t>
            </a:r>
            <a:r>
              <a:rPr lang="nl-BE" sz="1200" dirty="0"/>
              <a:t>Δ</a:t>
            </a:r>
            <a:r>
              <a:rPr lang="en-US" sz="1200" dirty="0"/>
              <a:t>SPI-2</a:t>
            </a:r>
            <a:r>
              <a:rPr lang="en-US" sz="1200" b="1" dirty="0"/>
              <a:t> </a:t>
            </a:r>
            <a:r>
              <a:rPr lang="en-US" sz="1200" i="1" dirty="0"/>
              <a:t>Salmonella</a:t>
            </a:r>
            <a:r>
              <a:rPr lang="en-US" sz="1200" dirty="0"/>
              <a:t>. Scale bar, 100 </a:t>
            </a:r>
            <a:r>
              <a:rPr lang="el-GR" sz="1200" dirty="0"/>
              <a:t>μ</a:t>
            </a:r>
            <a:r>
              <a:rPr lang="en-US" sz="1200" dirty="0"/>
              <a:t>m; zoom, 50 </a:t>
            </a:r>
            <a:r>
              <a:rPr lang="el-GR" sz="1200" dirty="0"/>
              <a:t>μ</a:t>
            </a:r>
            <a:r>
              <a:rPr lang="en-US" sz="1200" dirty="0"/>
              <a:t>m. (H) </a:t>
            </a:r>
            <a:r>
              <a:rPr lang="en-US" sz="1200" i="1" dirty="0"/>
              <a:t>Salmonella</a:t>
            </a:r>
            <a:r>
              <a:rPr lang="en-US" sz="1200" dirty="0"/>
              <a:t> burden in the indicated tissue of WT and OTULIN</a:t>
            </a:r>
            <a:r>
              <a:rPr lang="en-US" sz="1200" baseline="30000" dirty="0"/>
              <a:t>IEC-KO</a:t>
            </a:r>
            <a:r>
              <a:rPr lang="en-US" sz="1200" i="1" dirty="0"/>
              <a:t> </a:t>
            </a:r>
            <a:r>
              <a:rPr lang="en-US" sz="1200" dirty="0"/>
              <a:t>mice (n = 7) day 4 post infection with </a:t>
            </a:r>
            <a:r>
              <a:rPr lang="nl-BE" sz="1200" dirty="0"/>
              <a:t>Δ</a:t>
            </a:r>
            <a:r>
              <a:rPr lang="en-US" sz="1200" dirty="0"/>
              <a:t>SPI-1</a:t>
            </a:r>
            <a:r>
              <a:rPr lang="nl-BE" sz="1200" dirty="0"/>
              <a:t>Δ</a:t>
            </a:r>
            <a:r>
              <a:rPr lang="en-US" sz="1200" dirty="0"/>
              <a:t>SPI-2</a:t>
            </a:r>
            <a:r>
              <a:rPr lang="en-US" sz="1200" b="1" dirty="0"/>
              <a:t> </a:t>
            </a:r>
            <a:r>
              <a:rPr lang="en-US" sz="1200" i="1" dirty="0"/>
              <a:t>Salmonella</a:t>
            </a:r>
            <a:r>
              <a:rPr lang="en-US" sz="1200" dirty="0"/>
              <a:t>.</a:t>
            </a:r>
            <a:endParaRPr lang="en-BE" sz="1200" dirty="0"/>
          </a:p>
          <a:p>
            <a:endParaRPr lang="en-BE" sz="1200" dirty="0"/>
          </a:p>
        </p:txBody>
      </p:sp>
    </p:spTree>
    <p:extLst>
      <p:ext uri="{BB962C8B-B14F-4D97-AF65-F5344CB8AC3E}">
        <p14:creationId xmlns:p14="http://schemas.microsoft.com/office/powerpoint/2010/main" val="2754841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1</TotalTime>
  <Words>1034</Words>
  <Application>Microsoft Office PowerPoint</Application>
  <PresentationFormat>Widescreen</PresentationFormat>
  <Paragraphs>74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ert van Loo</dc:creator>
  <cp:lastModifiedBy>Geert van Loo</cp:lastModifiedBy>
  <cp:revision>48</cp:revision>
  <dcterms:created xsi:type="dcterms:W3CDTF">2022-10-19T07:21:06Z</dcterms:created>
  <dcterms:modified xsi:type="dcterms:W3CDTF">2023-07-18T09:04:58Z</dcterms:modified>
</cp:coreProperties>
</file>